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64F7C"/>
    <a:srgbClr val="6E98BE"/>
    <a:srgbClr val="00CD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985" autoAdjust="0"/>
    <p:restoredTop sz="94660"/>
  </p:normalViewPr>
  <p:slideViewPr>
    <p:cSldViewPr snapToGrid="0">
      <p:cViewPr>
        <p:scale>
          <a:sx n="75" d="100"/>
          <a:sy n="75" d="100"/>
        </p:scale>
        <p:origin x="1668" y="-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28162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2679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7673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3506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8293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944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6865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5996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115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147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777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ADDFE8-A74B-42CB-AB96-A2A72E5BB738}" type="datetimeFigureOut">
              <a:rPr kumimoji="1" lang="ja-JP" altLang="en-US" smtClean="0"/>
              <a:t>2019/4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49359-0116-44B2-9F90-9BB518A4BB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8754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emf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emf"/><Relationship Id="rId3" Type="http://schemas.openxmlformats.org/officeDocument/2006/relationships/image" Target="../media/image21.emf"/><Relationship Id="rId7" Type="http://schemas.openxmlformats.org/officeDocument/2006/relationships/image" Target="../media/image7.emf"/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4.emf"/><Relationship Id="rId5" Type="http://schemas.openxmlformats.org/officeDocument/2006/relationships/image" Target="../media/image23.emf"/><Relationship Id="rId4" Type="http://schemas.openxmlformats.org/officeDocument/2006/relationships/image" Target="../media/image22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7.emf"/><Relationship Id="rId7" Type="http://schemas.openxmlformats.org/officeDocument/2006/relationships/image" Target="../media/image31.emf"/><Relationship Id="rId2" Type="http://schemas.openxmlformats.org/officeDocument/2006/relationships/image" Target="../media/image26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0.emf"/><Relationship Id="rId5" Type="http://schemas.openxmlformats.org/officeDocument/2006/relationships/image" Target="../media/image29.emf"/><Relationship Id="rId4" Type="http://schemas.openxmlformats.org/officeDocument/2006/relationships/image" Target="../media/image28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33.emf"/><Relationship Id="rId7" Type="http://schemas.openxmlformats.org/officeDocument/2006/relationships/image" Target="../media/image37.emf"/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6.png"/><Relationship Id="rId5" Type="http://schemas.openxmlformats.org/officeDocument/2006/relationships/image" Target="../media/image35.emf"/><Relationship Id="rId4" Type="http://schemas.openxmlformats.org/officeDocument/2006/relationships/image" Target="../media/image34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39.emf"/><Relationship Id="rId7" Type="http://schemas.openxmlformats.org/officeDocument/2006/relationships/image" Target="../media/image36.png"/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2.emf"/><Relationship Id="rId5" Type="http://schemas.openxmlformats.org/officeDocument/2006/relationships/image" Target="../media/image41.emf"/><Relationship Id="rId4" Type="http://schemas.openxmlformats.org/officeDocument/2006/relationships/image" Target="../media/image40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8.emf"/><Relationship Id="rId3" Type="http://schemas.openxmlformats.org/officeDocument/2006/relationships/image" Target="../media/image44.emf"/><Relationship Id="rId7" Type="http://schemas.openxmlformats.org/officeDocument/2006/relationships/image" Target="../media/image7.emf"/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7.emf"/><Relationship Id="rId5" Type="http://schemas.openxmlformats.org/officeDocument/2006/relationships/image" Target="../media/image46.emf"/><Relationship Id="rId4" Type="http://schemas.openxmlformats.org/officeDocument/2006/relationships/image" Target="../media/image4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テキスト ボックス 140"/>
          <p:cNvSpPr txBox="1"/>
          <p:nvPr/>
        </p:nvSpPr>
        <p:spPr>
          <a:xfrm>
            <a:off x="59001" y="8413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 rotWithShape="1">
          <a:blip r:embed="rId2"/>
          <a:srcRect l="8855" t="6766" r="25369" b="15479"/>
          <a:stretch/>
        </p:blipFill>
        <p:spPr>
          <a:xfrm>
            <a:off x="480433" y="647843"/>
            <a:ext cx="2917280" cy="2880000"/>
          </a:xfrm>
          <a:prstGeom prst="rect">
            <a:avLst/>
          </a:prstGeom>
        </p:spPr>
      </p:pic>
      <p:sp>
        <p:nvSpPr>
          <p:cNvPr id="74" name="テキスト ボックス 73"/>
          <p:cNvSpPr txBox="1"/>
          <p:nvPr/>
        </p:nvSpPr>
        <p:spPr>
          <a:xfrm>
            <a:off x="1369847" y="361319"/>
            <a:ext cx="1138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fibroid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 rotWithShape="1">
          <a:blip r:embed="rId3"/>
          <a:srcRect l="8628" t="6360" r="25448" b="16003"/>
          <a:stretch/>
        </p:blipFill>
        <p:spPr>
          <a:xfrm>
            <a:off x="3476625" y="647843"/>
            <a:ext cx="2929120" cy="2880000"/>
          </a:xfrm>
          <a:prstGeom prst="rect">
            <a:avLst/>
          </a:prstGeom>
        </p:spPr>
      </p:pic>
      <p:sp>
        <p:nvSpPr>
          <p:cNvPr id="77" name="テキスト ボックス 76"/>
          <p:cNvSpPr txBox="1"/>
          <p:nvPr/>
        </p:nvSpPr>
        <p:spPr>
          <a:xfrm>
            <a:off x="4363142" y="361319"/>
            <a:ext cx="1156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dometriosi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 rotWithShape="1">
          <a:blip r:embed="rId4"/>
          <a:srcRect l="8654" t="6544" r="25422" b="15288"/>
          <a:stretch/>
        </p:blipFill>
        <p:spPr>
          <a:xfrm>
            <a:off x="484429" y="3847769"/>
            <a:ext cx="2909288" cy="28800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 rotWithShape="1">
          <a:blip r:embed="rId5"/>
          <a:srcRect l="8852" t="6279" r="25444" b="15553"/>
          <a:stretch/>
        </p:blipFill>
        <p:spPr>
          <a:xfrm>
            <a:off x="3491423" y="3847769"/>
            <a:ext cx="2899525" cy="2880000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6"/>
          <a:srcRect l="8876" t="6544" r="25642" b="15553"/>
          <a:stretch/>
        </p:blipFill>
        <p:spPr>
          <a:xfrm>
            <a:off x="489277" y="7026000"/>
            <a:ext cx="2899592" cy="2880000"/>
          </a:xfrm>
          <a:prstGeom prst="rect">
            <a:avLst/>
          </a:prstGeom>
        </p:spPr>
      </p:pic>
      <p:sp>
        <p:nvSpPr>
          <p:cNvPr id="101" name="テキスト ボックス 100"/>
          <p:cNvSpPr txBox="1"/>
          <p:nvPr/>
        </p:nvSpPr>
        <p:spPr>
          <a:xfrm>
            <a:off x="1326566" y="3564530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varian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3928729" y="3564530"/>
            <a:ext cx="2024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endometri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1066879" y="6738506"/>
            <a:ext cx="17443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cervic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図 13"/>
          <p:cNvPicPr>
            <a:picLocks noChangeAspect="1"/>
          </p:cNvPicPr>
          <p:nvPr/>
        </p:nvPicPr>
        <p:blipFill rotWithShape="1">
          <a:blip r:embed="rId7"/>
          <a:srcRect l="84209" t="41760" r="2" b="42900"/>
          <a:stretch/>
        </p:blipFill>
        <p:spPr>
          <a:xfrm>
            <a:off x="4404478" y="7753350"/>
            <a:ext cx="1377015" cy="1116912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8"/>
          <a:srcRect l="6861" t="93986" r="26993"/>
          <a:stretch/>
        </p:blipFill>
        <p:spPr>
          <a:xfrm>
            <a:off x="3327972" y="9168493"/>
            <a:ext cx="3530028" cy="2679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56637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2"/>
          <a:srcRect l="8189" t="10520" r="25002" b="20322"/>
          <a:stretch/>
        </p:blipFill>
        <p:spPr>
          <a:xfrm>
            <a:off x="90077" y="647446"/>
            <a:ext cx="3332414" cy="288000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 rotWithShape="1">
          <a:blip r:embed="rId3"/>
          <a:srcRect l="8410" t="10784" r="25001" b="20322"/>
          <a:stretch/>
        </p:blipFill>
        <p:spPr>
          <a:xfrm>
            <a:off x="3441175" y="647446"/>
            <a:ext cx="3334154" cy="28800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4"/>
          <a:srcRect l="8436" t="10991" r="25197" b="20381"/>
          <a:stretch/>
        </p:blipFill>
        <p:spPr>
          <a:xfrm>
            <a:off x="88331" y="3845807"/>
            <a:ext cx="3335907" cy="2880000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 rotWithShape="1">
          <a:blip r:embed="rId5"/>
          <a:srcRect l="8410" t="11578" r="25665" b="20323"/>
          <a:stretch/>
        </p:blipFill>
        <p:spPr>
          <a:xfrm>
            <a:off x="3438525" y="3845807"/>
            <a:ext cx="3339455" cy="288000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6"/>
          <a:srcRect l="88276" t="43706" b="44635"/>
          <a:stretch/>
        </p:blipFill>
        <p:spPr>
          <a:xfrm>
            <a:off x="4438650" y="7765315"/>
            <a:ext cx="1304743" cy="1083252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7"/>
          <a:srcRect l="8188" t="11048" r="25887" b="20323"/>
          <a:stretch/>
        </p:blipFill>
        <p:spPr>
          <a:xfrm>
            <a:off x="99449" y="7038170"/>
            <a:ext cx="3313670" cy="2880000"/>
          </a:xfrm>
          <a:prstGeom prst="rect">
            <a:avLst/>
          </a:prstGeom>
        </p:spPr>
      </p:pic>
      <p:sp>
        <p:nvSpPr>
          <p:cNvPr id="141" name="テキスト ボックス 140"/>
          <p:cNvSpPr txBox="1"/>
          <p:nvPr/>
        </p:nvSpPr>
        <p:spPr>
          <a:xfrm>
            <a:off x="59001" y="8413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187058" y="361319"/>
            <a:ext cx="1138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fibroid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530209" y="361319"/>
            <a:ext cx="1156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dometriosi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1143777" y="3564530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varian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4095796" y="3564530"/>
            <a:ext cx="2024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endometri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884090" y="6738506"/>
            <a:ext cx="17443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cervic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8"/>
          <a:srcRect l="6861" t="93986" r="26993"/>
          <a:stretch/>
        </p:blipFill>
        <p:spPr>
          <a:xfrm>
            <a:off x="3327972" y="9168493"/>
            <a:ext cx="3530028" cy="2679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4934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図 16"/>
          <p:cNvPicPr>
            <a:picLocks noChangeAspect="1"/>
          </p:cNvPicPr>
          <p:nvPr/>
        </p:nvPicPr>
        <p:blipFill rotWithShape="1">
          <a:blip r:embed="rId2"/>
          <a:srcRect l="84732" t="32777" r="3" b="34367"/>
          <a:stretch/>
        </p:blipFill>
        <p:spPr>
          <a:xfrm>
            <a:off x="4513283" y="7237324"/>
            <a:ext cx="1159407" cy="2083569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 rotWithShape="1">
          <a:blip r:embed="rId3"/>
          <a:srcRect l="4428" t="980" r="28320" b="17673"/>
          <a:stretch/>
        </p:blipFill>
        <p:spPr>
          <a:xfrm>
            <a:off x="322451" y="6981824"/>
            <a:ext cx="2851856" cy="2880000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4"/>
          <a:srcRect l="4726" t="529" r="28298" b="17659"/>
          <a:stretch/>
        </p:blipFill>
        <p:spPr>
          <a:xfrm>
            <a:off x="3618984" y="3818405"/>
            <a:ext cx="2824077" cy="28800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 rotWithShape="1">
          <a:blip r:embed="rId5"/>
          <a:srcRect l="4869" t="449" r="28542" b="17408"/>
          <a:stretch/>
        </p:blipFill>
        <p:spPr>
          <a:xfrm>
            <a:off x="350186" y="3818405"/>
            <a:ext cx="2796387" cy="2880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6"/>
          <a:srcRect l="4500" t="857" r="28027" b="17796"/>
          <a:stretch/>
        </p:blipFill>
        <p:spPr>
          <a:xfrm>
            <a:off x="3600403" y="605673"/>
            <a:ext cx="2861238" cy="2880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7"/>
          <a:srcRect l="4517" t="813" r="28010" b="17573"/>
          <a:stretch/>
        </p:blipFill>
        <p:spPr>
          <a:xfrm>
            <a:off x="322406" y="605673"/>
            <a:ext cx="2851947" cy="2880000"/>
          </a:xfrm>
          <a:prstGeom prst="rect">
            <a:avLst/>
          </a:prstGeom>
        </p:spPr>
      </p:pic>
      <p:sp>
        <p:nvSpPr>
          <p:cNvPr id="141" name="テキスト ボックス 140"/>
          <p:cNvSpPr txBox="1"/>
          <p:nvPr/>
        </p:nvSpPr>
        <p:spPr>
          <a:xfrm>
            <a:off x="59001" y="8413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179153" y="361319"/>
            <a:ext cx="1138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fibroid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452979" y="361319"/>
            <a:ext cx="1156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dometriosi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1135872" y="3564530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varian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4018566" y="3564530"/>
            <a:ext cx="2024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endometri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876185" y="6738506"/>
            <a:ext cx="17443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cervic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8"/>
          <a:srcRect l="6861" t="93986" r="26993"/>
          <a:stretch/>
        </p:blipFill>
        <p:spPr>
          <a:xfrm>
            <a:off x="3327972" y="9435193"/>
            <a:ext cx="3530028" cy="2679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70072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/>
          <p:cNvPicPr>
            <a:picLocks noChangeAspect="1"/>
          </p:cNvPicPr>
          <p:nvPr/>
        </p:nvPicPr>
        <p:blipFill rotWithShape="1">
          <a:blip r:embed="rId2"/>
          <a:srcRect l="11065" t="5219" r="26771" b="17408"/>
          <a:stretch/>
        </p:blipFill>
        <p:spPr>
          <a:xfrm>
            <a:off x="640824" y="654053"/>
            <a:ext cx="2771507" cy="28800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3"/>
          <a:srcRect l="10942" t="4947" r="26894" b="18210"/>
          <a:stretch/>
        </p:blipFill>
        <p:spPr>
          <a:xfrm>
            <a:off x="3458527" y="654053"/>
            <a:ext cx="2790620" cy="2880000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 rotWithShape="1">
          <a:blip r:embed="rId4"/>
          <a:srcRect l="10650" t="5300" r="26523" b="17857"/>
          <a:stretch/>
        </p:blipFill>
        <p:spPr>
          <a:xfrm>
            <a:off x="616370" y="3831199"/>
            <a:ext cx="2820414" cy="28800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5"/>
          <a:srcRect l="11065" t="4954" r="26108" b="17938"/>
          <a:stretch/>
        </p:blipFill>
        <p:spPr>
          <a:xfrm>
            <a:off x="3448476" y="3831199"/>
            <a:ext cx="2810722" cy="2880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6"/>
          <a:srcRect l="11064" t="4689" r="26993" b="17938"/>
          <a:stretch/>
        </p:blipFill>
        <p:spPr>
          <a:xfrm>
            <a:off x="645755" y="7019925"/>
            <a:ext cx="2761644" cy="2880000"/>
          </a:xfrm>
          <a:prstGeom prst="rect">
            <a:avLst/>
          </a:prstGeom>
        </p:spPr>
      </p:pic>
      <p:sp>
        <p:nvSpPr>
          <p:cNvPr id="141" name="テキスト ボックス 140"/>
          <p:cNvSpPr txBox="1"/>
          <p:nvPr/>
        </p:nvSpPr>
        <p:spPr>
          <a:xfrm>
            <a:off x="59001" y="8413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457351" y="361319"/>
            <a:ext cx="1138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fibroid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275794" y="361319"/>
            <a:ext cx="1156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dometriosi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1414070" y="3564530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varian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3841381" y="3564530"/>
            <a:ext cx="2024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endometri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1154383" y="6738506"/>
            <a:ext cx="17443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cervic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7"/>
          <a:srcRect l="6861" t="93986" r="26993"/>
          <a:stretch/>
        </p:blipFill>
        <p:spPr>
          <a:xfrm>
            <a:off x="3327972" y="9435193"/>
            <a:ext cx="3530028" cy="267956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8"/>
          <a:srcRect l="88271" t="42051" b="42845"/>
          <a:stretch/>
        </p:blipFill>
        <p:spPr>
          <a:xfrm>
            <a:off x="4505680" y="7834990"/>
            <a:ext cx="1174613" cy="126289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9116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/>
          <p:cNvPicPr>
            <a:picLocks noChangeAspect="1"/>
          </p:cNvPicPr>
          <p:nvPr/>
        </p:nvPicPr>
        <p:blipFill rotWithShape="1">
          <a:blip r:embed="rId2"/>
          <a:srcRect l="88935" t="38871" b="39666"/>
          <a:stretch/>
        </p:blipFill>
        <p:spPr>
          <a:xfrm>
            <a:off x="4505679" y="7344013"/>
            <a:ext cx="1174613" cy="1902274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 rotWithShape="1">
          <a:blip r:embed="rId3"/>
          <a:srcRect l="8410" t="5218" r="24780" b="14759"/>
          <a:stretch/>
        </p:blipFill>
        <p:spPr>
          <a:xfrm>
            <a:off x="511960" y="7015505"/>
            <a:ext cx="2880000" cy="2880000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 rotWithShape="1">
          <a:blip r:embed="rId4"/>
          <a:srcRect l="8632" t="5484" r="25002" b="14758"/>
          <a:stretch/>
        </p:blipFill>
        <p:spPr>
          <a:xfrm>
            <a:off x="3464612" y="3819415"/>
            <a:ext cx="2870432" cy="28800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 rotWithShape="1">
          <a:blip r:embed="rId5"/>
          <a:srcRect l="8293" t="4720" r="24897" b="14992"/>
          <a:stretch/>
        </p:blipFill>
        <p:spPr>
          <a:xfrm>
            <a:off x="516713" y="3819415"/>
            <a:ext cx="2870495" cy="2880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6"/>
          <a:srcRect l="8632" t="4953" r="25222" b="15024"/>
          <a:stretch/>
        </p:blipFill>
        <p:spPr>
          <a:xfrm>
            <a:off x="3474133" y="670065"/>
            <a:ext cx="2851391" cy="2880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7"/>
          <a:srcRect l="8410" t="5749" r="25444" b="15023"/>
          <a:stretch/>
        </p:blipFill>
        <p:spPr>
          <a:xfrm>
            <a:off x="511960" y="670065"/>
            <a:ext cx="2880000" cy="2880000"/>
          </a:xfrm>
          <a:prstGeom prst="rect">
            <a:avLst/>
          </a:prstGeom>
        </p:spPr>
      </p:pic>
      <p:sp>
        <p:nvSpPr>
          <p:cNvPr id="141" name="テキスト ボックス 140"/>
          <p:cNvSpPr txBox="1"/>
          <p:nvPr/>
        </p:nvSpPr>
        <p:spPr>
          <a:xfrm>
            <a:off x="59001" y="8413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382734" y="361319"/>
            <a:ext cx="1138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fibroid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321785" y="361319"/>
            <a:ext cx="1156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dometriosi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1339453" y="3564530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varian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3887372" y="3564530"/>
            <a:ext cx="2024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endometri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1079766" y="6738506"/>
            <a:ext cx="17443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cervic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8"/>
          <a:srcRect l="6861" t="93986" r="26993"/>
          <a:stretch/>
        </p:blipFill>
        <p:spPr>
          <a:xfrm>
            <a:off x="3327972" y="9435193"/>
            <a:ext cx="3530028" cy="2679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71334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図 21"/>
          <p:cNvPicPr>
            <a:picLocks noChangeAspect="1"/>
          </p:cNvPicPr>
          <p:nvPr/>
        </p:nvPicPr>
        <p:blipFill rotWithShape="1">
          <a:blip r:embed="rId2"/>
          <a:srcRect l="3522" t="3661" r="25391" b="10133"/>
          <a:stretch/>
        </p:blipFill>
        <p:spPr>
          <a:xfrm>
            <a:off x="419475" y="612161"/>
            <a:ext cx="2844590" cy="288000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3"/>
          <a:srcRect l="2806" t="3011" r="24632" b="10077"/>
          <a:stretch/>
        </p:blipFill>
        <p:spPr>
          <a:xfrm>
            <a:off x="3607233" y="612161"/>
            <a:ext cx="2880000" cy="28800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4"/>
          <a:srcRect l="3395" t="3365" r="24928" b="10076"/>
          <a:stretch/>
        </p:blipFill>
        <p:spPr>
          <a:xfrm>
            <a:off x="413525" y="3792247"/>
            <a:ext cx="2856490" cy="2880000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5"/>
          <a:srcRect l="3442" t="3424" r="25177" b="10371"/>
          <a:stretch/>
        </p:blipFill>
        <p:spPr>
          <a:xfrm>
            <a:off x="3619037" y="3792247"/>
            <a:ext cx="2856393" cy="2880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6"/>
          <a:srcRect b="67448"/>
          <a:stretch/>
        </p:blipFill>
        <p:spPr>
          <a:xfrm>
            <a:off x="3560270" y="7408649"/>
            <a:ext cx="1224000" cy="1765864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6"/>
          <a:srcRect t="32552" b="33750"/>
          <a:stretch/>
        </p:blipFill>
        <p:spPr>
          <a:xfrm>
            <a:off x="4569886" y="7346515"/>
            <a:ext cx="1224000" cy="1827998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 rotWithShape="1">
          <a:blip r:embed="rId6"/>
          <a:srcRect t="66269"/>
          <a:stretch/>
        </p:blipFill>
        <p:spPr>
          <a:xfrm>
            <a:off x="5786544" y="7344662"/>
            <a:ext cx="1224000" cy="1829851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7"/>
          <a:srcRect l="3395" t="3365" r="24928" b="10076"/>
          <a:stretch/>
        </p:blipFill>
        <p:spPr>
          <a:xfrm>
            <a:off x="413525" y="7029615"/>
            <a:ext cx="2856490" cy="2880000"/>
          </a:xfrm>
          <a:prstGeom prst="rect">
            <a:avLst/>
          </a:prstGeom>
        </p:spPr>
      </p:pic>
      <p:sp>
        <p:nvSpPr>
          <p:cNvPr id="141" name="テキスト ボックス 140"/>
          <p:cNvSpPr txBox="1"/>
          <p:nvPr/>
        </p:nvSpPr>
        <p:spPr>
          <a:xfrm>
            <a:off x="59001" y="8413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6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272544" y="361319"/>
            <a:ext cx="1138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fibroid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469190" y="361319"/>
            <a:ext cx="1156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dometriosi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1229263" y="3564530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varian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4034777" y="3564530"/>
            <a:ext cx="2024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endometri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969576" y="6738506"/>
            <a:ext cx="17443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cervic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8"/>
          <a:srcRect l="6861" t="93986" r="26993"/>
          <a:stretch/>
        </p:blipFill>
        <p:spPr>
          <a:xfrm>
            <a:off x="3327972" y="9435193"/>
            <a:ext cx="3530028" cy="2679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36701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/>
          <p:cNvPicPr>
            <a:picLocks noChangeAspect="1"/>
          </p:cNvPicPr>
          <p:nvPr/>
        </p:nvPicPr>
        <p:blipFill rotWithShape="1">
          <a:blip r:embed="rId2"/>
          <a:srcRect l="3101" t="3364" r="24928" b="10430"/>
          <a:stretch/>
        </p:blipFill>
        <p:spPr>
          <a:xfrm>
            <a:off x="307016" y="7026000"/>
            <a:ext cx="2880000" cy="2880000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 rotWithShape="1">
          <a:blip r:embed="rId3"/>
          <a:srcRect l="3396" t="3011" r="24633" b="10783"/>
          <a:stretch/>
        </p:blipFill>
        <p:spPr>
          <a:xfrm>
            <a:off x="3705041" y="3828987"/>
            <a:ext cx="2880000" cy="2880000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 rotWithShape="1">
          <a:blip r:embed="rId4"/>
          <a:srcRect l="3396" t="3011" r="24633" b="10430"/>
          <a:stretch/>
        </p:blipFill>
        <p:spPr>
          <a:xfrm>
            <a:off x="312894" y="3828987"/>
            <a:ext cx="2868245" cy="2880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5"/>
          <a:srcRect l="3101" t="3364" r="24633" b="10430"/>
          <a:stretch/>
        </p:blipFill>
        <p:spPr>
          <a:xfrm>
            <a:off x="3699140" y="579686"/>
            <a:ext cx="2891803" cy="2880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6"/>
          <a:srcRect l="3275" t="2876" r="24753" b="10565"/>
          <a:stretch/>
        </p:blipFill>
        <p:spPr>
          <a:xfrm>
            <a:off x="312894" y="579686"/>
            <a:ext cx="2868245" cy="2880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7"/>
          <a:srcRect b="67448"/>
          <a:stretch/>
        </p:blipFill>
        <p:spPr>
          <a:xfrm>
            <a:off x="3560270" y="7408649"/>
            <a:ext cx="1224000" cy="1765864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 rotWithShape="1">
          <a:blip r:embed="rId7"/>
          <a:srcRect t="32552" b="33750"/>
          <a:stretch/>
        </p:blipFill>
        <p:spPr>
          <a:xfrm>
            <a:off x="4569886" y="7346515"/>
            <a:ext cx="1224000" cy="1827998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 rotWithShape="1">
          <a:blip r:embed="rId7"/>
          <a:srcRect t="66269"/>
          <a:stretch/>
        </p:blipFill>
        <p:spPr>
          <a:xfrm>
            <a:off x="5786544" y="7344662"/>
            <a:ext cx="1224000" cy="1829851"/>
          </a:xfrm>
          <a:prstGeom prst="rect">
            <a:avLst/>
          </a:prstGeom>
        </p:spPr>
      </p:pic>
      <p:sp>
        <p:nvSpPr>
          <p:cNvPr id="141" name="テキスト ボックス 140"/>
          <p:cNvSpPr txBox="1"/>
          <p:nvPr/>
        </p:nvSpPr>
        <p:spPr>
          <a:xfrm>
            <a:off x="59001" y="8413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7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177790" y="361319"/>
            <a:ext cx="1138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fibroid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566998" y="361319"/>
            <a:ext cx="1156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dometriosi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1134509" y="3564530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varian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4132585" y="3564530"/>
            <a:ext cx="2024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endometri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874822" y="6738506"/>
            <a:ext cx="17443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cervic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8"/>
          <a:srcRect l="6861" t="93986" r="26993"/>
          <a:stretch/>
        </p:blipFill>
        <p:spPr>
          <a:xfrm>
            <a:off x="3327972" y="9435193"/>
            <a:ext cx="3530028" cy="2679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41958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図 20"/>
          <p:cNvPicPr>
            <a:picLocks noChangeAspect="1"/>
          </p:cNvPicPr>
          <p:nvPr/>
        </p:nvPicPr>
        <p:blipFill rotWithShape="1">
          <a:blip r:embed="rId2"/>
          <a:srcRect l="7882" t="10788" r="25161" b="20319"/>
          <a:stretch/>
        </p:blipFill>
        <p:spPr>
          <a:xfrm>
            <a:off x="203414" y="697230"/>
            <a:ext cx="3352615" cy="288000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 rotWithShape="1">
          <a:blip r:embed="rId3"/>
          <a:srcRect l="7888" t="10585" r="25450" b="20168"/>
          <a:stretch/>
        </p:blipFill>
        <p:spPr>
          <a:xfrm>
            <a:off x="3537184" y="684530"/>
            <a:ext cx="3320816" cy="28800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4"/>
          <a:srcRect l="8071" t="10524" r="25562" b="19876"/>
          <a:stretch/>
        </p:blipFill>
        <p:spPr>
          <a:xfrm>
            <a:off x="107635" y="3824974"/>
            <a:ext cx="3289340" cy="2880000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 rotWithShape="1">
          <a:blip r:embed="rId5"/>
          <a:srcRect l="7821" t="10430" r="25223" b="20323"/>
          <a:stretch/>
        </p:blipFill>
        <p:spPr>
          <a:xfrm>
            <a:off x="3445479" y="3824974"/>
            <a:ext cx="3335510" cy="2880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 rotWithShape="1">
          <a:blip r:embed="rId6"/>
          <a:srcRect l="8115" t="10784" r="25518" b="19969"/>
          <a:stretch/>
        </p:blipFill>
        <p:spPr>
          <a:xfrm>
            <a:off x="99244" y="7028317"/>
            <a:ext cx="3306122" cy="2880000"/>
          </a:xfrm>
          <a:prstGeom prst="rect">
            <a:avLst/>
          </a:prstGeom>
        </p:spPr>
      </p:pic>
      <p:sp>
        <p:nvSpPr>
          <p:cNvPr id="141" name="テキスト ボックス 140"/>
          <p:cNvSpPr txBox="1"/>
          <p:nvPr/>
        </p:nvSpPr>
        <p:spPr>
          <a:xfrm>
            <a:off x="59001" y="8413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1183079" y="361319"/>
            <a:ext cx="11384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fibroid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4535191" y="361319"/>
            <a:ext cx="11560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ndometriosi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1139798" y="3564530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varian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4100778" y="3564530"/>
            <a:ext cx="2024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endometri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880111" y="6738506"/>
            <a:ext cx="17443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terine cervical cance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7"/>
          <a:srcRect l="6861" t="93986" r="26993"/>
          <a:stretch/>
        </p:blipFill>
        <p:spPr>
          <a:xfrm>
            <a:off x="3327972" y="9435193"/>
            <a:ext cx="3530028" cy="267956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8"/>
          <a:srcRect l="88051" t="43287" b="44701"/>
          <a:stretch/>
        </p:blipFill>
        <p:spPr>
          <a:xfrm>
            <a:off x="4169111" y="7518076"/>
            <a:ext cx="1847750" cy="1550745"/>
          </a:xfrm>
          <a:prstGeom prst="rect">
            <a:avLst/>
          </a:prstGeom>
        </p:spPr>
      </p:pic>
      <p:pic>
        <p:nvPicPr>
          <p:cNvPr id="28" name="図 27"/>
          <p:cNvPicPr>
            <a:picLocks noChangeAspect="1"/>
          </p:cNvPicPr>
          <p:nvPr/>
        </p:nvPicPr>
        <p:blipFill rotWithShape="1">
          <a:blip r:embed="rId2"/>
          <a:srcRect l="7882" t="10788" r="25161" b="20319"/>
          <a:stretch/>
        </p:blipFill>
        <p:spPr>
          <a:xfrm>
            <a:off x="75998" y="652780"/>
            <a:ext cx="3352615" cy="2880000"/>
          </a:xfrm>
          <a:prstGeom prst="rect">
            <a:avLst/>
          </a:prstGeom>
        </p:spPr>
      </p:pic>
      <p:pic>
        <p:nvPicPr>
          <p:cNvPr id="29" name="図 28"/>
          <p:cNvPicPr>
            <a:picLocks noChangeAspect="1"/>
          </p:cNvPicPr>
          <p:nvPr/>
        </p:nvPicPr>
        <p:blipFill rotWithShape="1">
          <a:blip r:embed="rId3"/>
          <a:srcRect l="7888" t="10585" r="25450" b="20168"/>
          <a:stretch/>
        </p:blipFill>
        <p:spPr>
          <a:xfrm>
            <a:off x="3452826" y="652780"/>
            <a:ext cx="3320816" cy="28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09696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437</TotalTime>
  <Words>112</Words>
  <Application>Microsoft Office PowerPoint</Application>
  <PresentationFormat>A4 210 x 297 mm</PresentationFormat>
  <Paragraphs>48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4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suo masuda</dc:creator>
  <cp:lastModifiedBy>masuda tatsuo</cp:lastModifiedBy>
  <cp:revision>189</cp:revision>
  <cp:lastPrinted>2018-04-16T17:19:51Z</cp:lastPrinted>
  <dcterms:created xsi:type="dcterms:W3CDTF">2018-04-01T08:30:19Z</dcterms:created>
  <dcterms:modified xsi:type="dcterms:W3CDTF">2019-04-04T23:24:54Z</dcterms:modified>
</cp:coreProperties>
</file>